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44" r:id="rId2"/>
    <p:sldId id="345" r:id="rId3"/>
    <p:sldId id="346" r:id="rId4"/>
    <p:sldId id="347" r:id="rId5"/>
    <p:sldId id="348" r:id="rId6"/>
    <p:sldId id="350" r:id="rId7"/>
    <p:sldId id="351" r:id="rId8"/>
    <p:sldId id="352" r:id="rId9"/>
    <p:sldId id="353" r:id="rId10"/>
    <p:sldId id="354" r:id="rId11"/>
    <p:sldId id="355" r:id="rId12"/>
    <p:sldId id="356" r:id="rId13"/>
    <p:sldId id="349" r:id="rId14"/>
    <p:sldId id="357" r:id="rId1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34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1B4A20-CA98-A241-915D-2AE15E0F52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462DDEE-2518-C446-EBA5-1FB0FF8029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14634E1-3D2C-58F8-5C62-83A2B3E62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A66D487-1036-595B-C4A0-A16DB99FA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780F70C-63DC-D2BA-D377-3DD705606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5149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155D8E5-3B1B-60B6-58B7-7E652D5B19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7E18BDF-D410-0A40-9592-E84F3CF7A3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C549BF0-B1C7-8D08-921F-6C2D626AF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791AF1D-F41F-3C68-158D-71475635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C1D90B1-1C79-AF07-8A2D-9421A9A2B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2579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D9B3A2E-5DB7-1EEB-19AC-22E34CF9E5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DCD6EAE-3FFC-85AD-E947-4276FF71BF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5394B4D-B3D7-155D-28D0-179C513A7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BA565-C223-C833-3BFE-7C17898C1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E68D63A-DAFF-2565-B478-D27188D93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3362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98F6FB7-00E3-DB89-ECB1-B5664F271C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33720AC-8F57-15AA-FC34-E3A715270C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63970F7-FB23-3DAF-0BD3-2D302F484F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778540-BBF6-51D8-7676-FD2AF176F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6E32DE0-8BBB-77B0-EF5B-800F49BFC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4708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39B26F3-BFC2-E87A-7396-C0A559800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5F82533-1F95-80CD-9937-77C33D2CAB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B9823F3-05EA-A303-2A5F-D6A68F0B5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5378B9C-D9DF-92F6-DB5C-7D6E403E2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4B43F74-F8B1-153F-10D0-81570575C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539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2E0850-79D3-C59C-36D4-4F5BDF02FE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FFA01AB-BDCE-B581-5441-00C86093D7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8EF7C7C-0B4A-39BA-50EA-85CD44300B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B1ACE3D-00ED-91BF-F0B5-9CB390856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48388E9-975A-A341-8823-1A1539C14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65FC33E-3EB8-219E-9855-83061F39A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6123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FF77F57-9CCB-720B-C0FA-4724A3247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0073A5A-0F49-485F-8E30-E11A47D063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3427AB0-A148-2367-42D4-177197B947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ACF1AF0-96BA-033C-A31A-0A3AF99A07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626F44C-450F-544B-1E3F-136A649326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C2A5A1C3-D315-7BCC-05AC-B0C3B0469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0F9FE06-DE2B-C6AE-651F-3AB9F50C0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7F459E4-ED1B-EBDC-02CF-B04179E109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3300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7DAD640-FE39-BA7D-B611-4C6D50A7E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07711F7-4355-DC4E-129B-0B8A914BF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3F531C8-385D-BC37-3F42-A0496ACBD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3D24A9FC-77A9-A0A8-178C-B7E0E1F92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6036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D23D53A-420C-BD0B-AE60-D5E081375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536B587-8D61-6F5D-DA1C-B43024F85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8D68DF40-F9C6-7A3A-B016-989BEE273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0245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6250540-78EC-694B-0B2F-4A138C7B5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5412295-F830-3E3D-28EA-DB28A1F226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4179297-E5B2-35FF-DD62-B156A81D06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BF6EA92-A068-78E0-9D5C-A5F903419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A50A6B0-44A8-BD2F-4B86-FA54B6348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30EEB0D-1516-50C1-5518-27F0C2D40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8133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22F90EF-28FB-9FF3-D9ED-1EC5FD6CDD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2B98F2E4-E599-FEB9-E521-1669C5C3B3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3DD385E-A357-7383-D7FE-7055FF188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D52ECEB-BCBB-E50B-0ED7-E1136D54C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941B801-1B48-73B3-7166-C00342D89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24451CA-42AA-F0E1-E0F7-52D83CA69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4363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AF53451F-9388-BE96-222F-0B5E14C7C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CAA4221-5F35-B465-263A-D45C23DE07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72B9EC-5899-8B0D-1D02-3D62C1B047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355E8-AB4D-4133-B045-D3BF1D1BE791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66C71C9-D668-6A84-436E-7207BFEABD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07FB84-DFC2-1FE7-0D04-F6A6042C27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0F9B15-AB54-422E-99CD-76FD4D746F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8456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18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CAFA8AD7-E2CA-82C6-7CCD-92F335C030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97651">
            <a:off x="3312392" y="145916"/>
            <a:ext cx="6909629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ACF82E2-C067-A80A-4004-335F15CAE7CF}"/>
              </a:ext>
            </a:extLst>
          </p:cNvPr>
          <p:cNvSpPr txBox="1"/>
          <p:nvPr/>
        </p:nvSpPr>
        <p:spPr>
          <a:xfrm>
            <a:off x="0" y="0"/>
            <a:ext cx="26513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/>
              <a:t>E15-P10_mKO2-_1-2</a:t>
            </a:r>
          </a:p>
        </p:txBody>
      </p:sp>
    </p:spTree>
    <p:extLst>
      <p:ext uri="{BB962C8B-B14F-4D97-AF65-F5344CB8AC3E}">
        <p14:creationId xmlns:p14="http://schemas.microsoft.com/office/powerpoint/2010/main" val="31357501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>
            <a:extLst>
              <a:ext uri="{FF2B5EF4-FFF2-40B4-BE49-F238E27FC236}">
                <a16:creationId xmlns:a16="http://schemas.microsoft.com/office/drawing/2014/main" id="{2DC81FE5-F187-7F3A-6314-CC3948B118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70723">
            <a:off x="1627191" y="-250214"/>
            <a:ext cx="6480000" cy="6431581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66211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A9FE4A7C-99D9-DEC2-1FE0-FB14652F31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70723">
            <a:off x="1584058" y="-284720"/>
            <a:ext cx="6480000" cy="6431581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301005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E6AFF6E7-B794-56A2-79DD-CBC26E1A29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70723">
            <a:off x="1627191" y="-250214"/>
            <a:ext cx="6480000" cy="6431581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7" name="직선 연결선 6">
            <a:extLst>
              <a:ext uri="{FF2B5EF4-FFF2-40B4-BE49-F238E27FC236}">
                <a16:creationId xmlns:a16="http://schemas.microsoft.com/office/drawing/2014/main" id="{3A34B364-F355-CFED-7820-BB0B4984686E}"/>
              </a:ext>
            </a:extLst>
          </p:cNvPr>
          <p:cNvCxnSpPr>
            <a:cxnSpLocks/>
          </p:cNvCxnSpPr>
          <p:nvPr/>
        </p:nvCxnSpPr>
        <p:spPr>
          <a:xfrm>
            <a:off x="5425440" y="6248400"/>
            <a:ext cx="918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075344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E12DA4BE-55CF-6FE9-E2AB-CC5E5C6D48A5}"/>
              </a:ext>
            </a:extLst>
          </p:cNvPr>
          <p:cNvSpPr txBox="1"/>
          <p:nvPr/>
        </p:nvSpPr>
        <p:spPr>
          <a:xfrm>
            <a:off x="253330" y="231339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atb2</a:t>
            </a:r>
            <a:endParaRPr lang="ko-KR" altLang="en-US" b="1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50DD6C49-C406-9CE5-0C7B-6A3AAE9071FF}"/>
              </a:ext>
            </a:extLst>
          </p:cNvPr>
          <p:cNvCxnSpPr>
            <a:cxnSpLocks/>
          </p:cNvCxnSpPr>
          <p:nvPr/>
        </p:nvCxnSpPr>
        <p:spPr>
          <a:xfrm>
            <a:off x="686302" y="1483502"/>
            <a:ext cx="1094149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115C2CCA-0C9F-58F1-B97A-0F7D454390F0}"/>
              </a:ext>
            </a:extLst>
          </p:cNvPr>
          <p:cNvGrpSpPr/>
          <p:nvPr/>
        </p:nvGrpSpPr>
        <p:grpSpPr>
          <a:xfrm>
            <a:off x="1458075" y="1140198"/>
            <a:ext cx="8766474" cy="5022592"/>
            <a:chOff x="1458075" y="1140198"/>
            <a:chExt cx="8766474" cy="5022592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1CFE89AB-DEF3-AA3A-056F-EB55690CE4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39029" y="1483502"/>
              <a:ext cx="1361837" cy="4320000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6EDFB65E-3029-1D3F-8E8E-871A3722F32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762703" y="1483502"/>
              <a:ext cx="1361837" cy="43200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357C0973-EE0F-E714-3A4E-A2CCF37F0AE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00866" y="1483502"/>
              <a:ext cx="1352727" cy="43200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8034A9C-4518-0681-874D-F9849294064D}"/>
                </a:ext>
              </a:extLst>
            </p:cNvPr>
            <p:cNvSpPr txBox="1"/>
            <p:nvPr/>
          </p:nvSpPr>
          <p:spPr>
            <a:xfrm>
              <a:off x="2055006" y="5855013"/>
              <a:ext cx="405697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 (mKO2-)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FA7C85A-2D5A-CAD9-B3B2-5276F35DC461}"/>
                </a:ext>
              </a:extLst>
            </p:cNvPr>
            <p:cNvSpPr txBox="1"/>
            <p:nvPr/>
          </p:nvSpPr>
          <p:spPr>
            <a:xfrm>
              <a:off x="6176701" y="5855013"/>
              <a:ext cx="4047848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18 </a:t>
              </a:r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(mKO2+)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그림 16">
              <a:extLst>
                <a:ext uri="{FF2B5EF4-FFF2-40B4-BE49-F238E27FC236}">
                  <a16:creationId xmlns:a16="http://schemas.microsoft.com/office/drawing/2014/main" id="{36CDBEB7-B4C2-6169-C1D4-1F60D5E2C07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60723" y="1483502"/>
              <a:ext cx="1352727" cy="4320000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F7C00AA0-C438-A64C-4E64-A969B6AD8AF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513450" y="1483502"/>
              <a:ext cx="1352727" cy="4320000"/>
            </a:xfrm>
            <a:prstGeom prst="rect">
              <a:avLst/>
            </a:prstGeom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9F7D9D53-2A72-35C1-D670-B83F3907B21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855844" y="1483502"/>
              <a:ext cx="1352727" cy="4320000"/>
            </a:xfrm>
            <a:prstGeom prst="rect">
              <a:avLst/>
            </a:prstGeom>
          </p:spPr>
        </p:pic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4847896D-DD9B-741F-8B95-C6D8FD178837}"/>
                </a:ext>
              </a:extLst>
            </p:cNvPr>
            <p:cNvCxnSpPr>
              <a:cxnSpLocks/>
            </p:cNvCxnSpPr>
            <p:nvPr/>
          </p:nvCxnSpPr>
          <p:spPr>
            <a:xfrm>
              <a:off x="2038852" y="2347502"/>
              <a:ext cx="8172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DE808D57-34B7-D557-C8BF-F5623623A046}"/>
                </a:ext>
              </a:extLst>
            </p:cNvPr>
            <p:cNvCxnSpPr>
              <a:cxnSpLocks/>
            </p:cNvCxnSpPr>
            <p:nvPr/>
          </p:nvCxnSpPr>
          <p:spPr>
            <a:xfrm>
              <a:off x="2048377" y="3211502"/>
              <a:ext cx="8172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D5C08778-D2FA-8FD2-AF99-D32586A2CE4E}"/>
                </a:ext>
              </a:extLst>
            </p:cNvPr>
            <p:cNvCxnSpPr>
              <a:cxnSpLocks/>
            </p:cNvCxnSpPr>
            <p:nvPr/>
          </p:nvCxnSpPr>
          <p:spPr>
            <a:xfrm>
              <a:off x="2038852" y="4075502"/>
              <a:ext cx="8172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AFC5295-39FC-51E5-444B-FB06804ACA9E}"/>
                </a:ext>
              </a:extLst>
            </p:cNvPr>
            <p:cNvCxnSpPr>
              <a:cxnSpLocks/>
            </p:cNvCxnSpPr>
            <p:nvPr/>
          </p:nvCxnSpPr>
          <p:spPr>
            <a:xfrm>
              <a:off x="2029327" y="4939502"/>
              <a:ext cx="8172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이등변 삼각형 3">
              <a:extLst>
                <a:ext uri="{FF2B5EF4-FFF2-40B4-BE49-F238E27FC236}">
                  <a16:creationId xmlns:a16="http://schemas.microsoft.com/office/drawing/2014/main" id="{9D9CDF6E-7853-440C-C23F-782D3C0FE88F}"/>
                </a:ext>
              </a:extLst>
            </p:cNvPr>
            <p:cNvSpPr/>
            <p:nvPr/>
          </p:nvSpPr>
          <p:spPr>
            <a:xfrm rot="14012860">
              <a:off x="5660853" y="2171718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" name="이등변 삼각형 21">
              <a:extLst>
                <a:ext uri="{FF2B5EF4-FFF2-40B4-BE49-F238E27FC236}">
                  <a16:creationId xmlns:a16="http://schemas.microsoft.com/office/drawing/2014/main" id="{E4D98362-7573-119C-8749-E61DF2AE977A}"/>
                </a:ext>
              </a:extLst>
            </p:cNvPr>
            <p:cNvSpPr/>
            <p:nvPr/>
          </p:nvSpPr>
          <p:spPr>
            <a:xfrm rot="14012860">
              <a:off x="5805279" y="2227077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이등변 삼각형 28">
              <a:extLst>
                <a:ext uri="{FF2B5EF4-FFF2-40B4-BE49-F238E27FC236}">
                  <a16:creationId xmlns:a16="http://schemas.microsoft.com/office/drawing/2014/main" id="{154FD214-D660-C635-C699-AEF6EE92BA1A}"/>
                </a:ext>
              </a:extLst>
            </p:cNvPr>
            <p:cNvSpPr/>
            <p:nvPr/>
          </p:nvSpPr>
          <p:spPr>
            <a:xfrm rot="14012860">
              <a:off x="5762258" y="2370105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" name="이등변 삼각형 29">
              <a:extLst>
                <a:ext uri="{FF2B5EF4-FFF2-40B4-BE49-F238E27FC236}">
                  <a16:creationId xmlns:a16="http://schemas.microsoft.com/office/drawing/2014/main" id="{0BC9012C-BF3B-658D-F4EA-B5A144A4644B}"/>
                </a:ext>
              </a:extLst>
            </p:cNvPr>
            <p:cNvSpPr/>
            <p:nvPr/>
          </p:nvSpPr>
          <p:spPr>
            <a:xfrm rot="14012860">
              <a:off x="5790334" y="2500285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이등변 삼각형 40">
              <a:extLst>
                <a:ext uri="{FF2B5EF4-FFF2-40B4-BE49-F238E27FC236}">
                  <a16:creationId xmlns:a16="http://schemas.microsoft.com/office/drawing/2014/main" id="{7F9AA3F4-842A-55F2-130F-17709C3084FC}"/>
                </a:ext>
              </a:extLst>
            </p:cNvPr>
            <p:cNvSpPr/>
            <p:nvPr/>
          </p:nvSpPr>
          <p:spPr>
            <a:xfrm rot="14012860">
              <a:off x="5918232" y="2707992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2" name="이등변 삼각형 41">
              <a:extLst>
                <a:ext uri="{FF2B5EF4-FFF2-40B4-BE49-F238E27FC236}">
                  <a16:creationId xmlns:a16="http://schemas.microsoft.com/office/drawing/2014/main" id="{BDFB67E2-AE1F-5BF7-5FE6-0F61793B2C2A}"/>
                </a:ext>
              </a:extLst>
            </p:cNvPr>
            <p:cNvSpPr/>
            <p:nvPr/>
          </p:nvSpPr>
          <p:spPr>
            <a:xfrm rot="14012860">
              <a:off x="5688641" y="3018316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3" name="이등변 삼각형 42">
              <a:extLst>
                <a:ext uri="{FF2B5EF4-FFF2-40B4-BE49-F238E27FC236}">
                  <a16:creationId xmlns:a16="http://schemas.microsoft.com/office/drawing/2014/main" id="{099BB583-E405-C5CF-14A0-B032F9CDA437}"/>
                </a:ext>
              </a:extLst>
            </p:cNvPr>
            <p:cNvSpPr/>
            <p:nvPr/>
          </p:nvSpPr>
          <p:spPr>
            <a:xfrm rot="14012860">
              <a:off x="5656249" y="2913389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이등변 삼각형 43">
              <a:extLst>
                <a:ext uri="{FF2B5EF4-FFF2-40B4-BE49-F238E27FC236}">
                  <a16:creationId xmlns:a16="http://schemas.microsoft.com/office/drawing/2014/main" id="{684A6F51-DDC0-DD14-C28D-7A40FB9CA70B}"/>
                </a:ext>
              </a:extLst>
            </p:cNvPr>
            <p:cNvSpPr/>
            <p:nvPr/>
          </p:nvSpPr>
          <p:spPr>
            <a:xfrm rot="14012860">
              <a:off x="4911669" y="2135501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5" name="이등변 삼각형 44">
              <a:extLst>
                <a:ext uri="{FF2B5EF4-FFF2-40B4-BE49-F238E27FC236}">
                  <a16:creationId xmlns:a16="http://schemas.microsoft.com/office/drawing/2014/main" id="{0AC19A81-0553-DF12-DF53-AB16D76929DA}"/>
                </a:ext>
              </a:extLst>
            </p:cNvPr>
            <p:cNvSpPr/>
            <p:nvPr/>
          </p:nvSpPr>
          <p:spPr>
            <a:xfrm rot="14012860">
              <a:off x="4911669" y="2454496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6" name="이등변 삼각형 45">
              <a:extLst>
                <a:ext uri="{FF2B5EF4-FFF2-40B4-BE49-F238E27FC236}">
                  <a16:creationId xmlns:a16="http://schemas.microsoft.com/office/drawing/2014/main" id="{3C07B6AE-A093-05CB-001E-C3387C8C87D8}"/>
                </a:ext>
              </a:extLst>
            </p:cNvPr>
            <p:cNvSpPr/>
            <p:nvPr/>
          </p:nvSpPr>
          <p:spPr>
            <a:xfrm rot="14012860">
              <a:off x="5399742" y="2370783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7" name="이등변 삼각형 46">
              <a:extLst>
                <a:ext uri="{FF2B5EF4-FFF2-40B4-BE49-F238E27FC236}">
                  <a16:creationId xmlns:a16="http://schemas.microsoft.com/office/drawing/2014/main" id="{E5DC308E-8E7D-3CB7-186F-B6289486E7D5}"/>
                </a:ext>
              </a:extLst>
            </p:cNvPr>
            <p:cNvSpPr/>
            <p:nvPr/>
          </p:nvSpPr>
          <p:spPr>
            <a:xfrm rot="14012860">
              <a:off x="5588769" y="2375576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" name="이등변 삼각형 47">
              <a:extLst>
                <a:ext uri="{FF2B5EF4-FFF2-40B4-BE49-F238E27FC236}">
                  <a16:creationId xmlns:a16="http://schemas.microsoft.com/office/drawing/2014/main" id="{55C060A5-D31F-8C1A-9C48-09BBEB84B987}"/>
                </a:ext>
              </a:extLst>
            </p:cNvPr>
            <p:cNvSpPr/>
            <p:nvPr/>
          </p:nvSpPr>
          <p:spPr>
            <a:xfrm rot="14012860">
              <a:off x="5486980" y="2633001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9" name="이등변 삼각형 48">
              <a:extLst>
                <a:ext uri="{FF2B5EF4-FFF2-40B4-BE49-F238E27FC236}">
                  <a16:creationId xmlns:a16="http://schemas.microsoft.com/office/drawing/2014/main" id="{8C9541E3-359E-9843-EF5E-F9E99169981C}"/>
                </a:ext>
              </a:extLst>
            </p:cNvPr>
            <p:cNvSpPr/>
            <p:nvPr/>
          </p:nvSpPr>
          <p:spPr>
            <a:xfrm rot="14012860">
              <a:off x="5432795" y="2737962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0" name="이등변 삼각형 49">
              <a:extLst>
                <a:ext uri="{FF2B5EF4-FFF2-40B4-BE49-F238E27FC236}">
                  <a16:creationId xmlns:a16="http://schemas.microsoft.com/office/drawing/2014/main" id="{239B1D89-C1FB-A009-7DDA-7D86AF6FEF11}"/>
                </a:ext>
              </a:extLst>
            </p:cNvPr>
            <p:cNvSpPr/>
            <p:nvPr/>
          </p:nvSpPr>
          <p:spPr>
            <a:xfrm rot="14012860">
              <a:off x="5209559" y="2868964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1" name="이등변 삼각형 50">
              <a:extLst>
                <a:ext uri="{FF2B5EF4-FFF2-40B4-BE49-F238E27FC236}">
                  <a16:creationId xmlns:a16="http://schemas.microsoft.com/office/drawing/2014/main" id="{B7908484-8F3A-1F24-E47F-0E7C05FA4651}"/>
                </a:ext>
              </a:extLst>
            </p:cNvPr>
            <p:cNvSpPr/>
            <p:nvPr/>
          </p:nvSpPr>
          <p:spPr>
            <a:xfrm rot="14012860">
              <a:off x="4864891" y="2631286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F881307B-ADBF-730F-2C45-FF3A0A2B40B0}"/>
                </a:ext>
              </a:extLst>
            </p:cNvPr>
            <p:cNvCxnSpPr/>
            <p:nvPr/>
          </p:nvCxnSpPr>
          <p:spPr>
            <a:xfrm>
              <a:off x="2157873" y="5692140"/>
              <a:ext cx="334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34101C2-105A-1E74-41A4-67574C886D91}"/>
                </a:ext>
              </a:extLst>
            </p:cNvPr>
            <p:cNvSpPr txBox="1"/>
            <p:nvPr/>
          </p:nvSpPr>
          <p:spPr>
            <a:xfrm>
              <a:off x="2055006" y="5453229"/>
              <a:ext cx="5405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um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58C544D-D860-0D4B-D35D-70A5861D4D47}"/>
                </a:ext>
              </a:extLst>
            </p:cNvPr>
            <p:cNvSpPr txBox="1"/>
            <p:nvPr/>
          </p:nvSpPr>
          <p:spPr>
            <a:xfrm>
              <a:off x="2072397" y="1140198"/>
              <a:ext cx="129510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atb2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31C6B23-D5FA-90F1-AB73-C68CFCE1618D}"/>
                </a:ext>
              </a:extLst>
            </p:cNvPr>
            <p:cNvSpPr txBox="1"/>
            <p:nvPr/>
          </p:nvSpPr>
          <p:spPr>
            <a:xfrm>
              <a:off x="3429678" y="1140198"/>
              <a:ext cx="129510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47838C6-6760-BD83-1BB4-30A45F6BCD9B}"/>
                </a:ext>
              </a:extLst>
            </p:cNvPr>
            <p:cNvSpPr txBox="1"/>
            <p:nvPr/>
          </p:nvSpPr>
          <p:spPr>
            <a:xfrm>
              <a:off x="4800899" y="1140198"/>
              <a:ext cx="129510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tb2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0EB0CB4-F5BD-A84E-B672-8224C2E43DF9}"/>
                </a:ext>
              </a:extLst>
            </p:cNvPr>
            <p:cNvSpPr txBox="1"/>
            <p:nvPr/>
          </p:nvSpPr>
          <p:spPr>
            <a:xfrm>
              <a:off x="6168199" y="1140198"/>
              <a:ext cx="129510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atb2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458B710-FCE9-18FE-6FB0-2ED62504E244}"/>
                </a:ext>
              </a:extLst>
            </p:cNvPr>
            <p:cNvSpPr txBox="1"/>
            <p:nvPr/>
          </p:nvSpPr>
          <p:spPr>
            <a:xfrm>
              <a:off x="7525480" y="1140198"/>
              <a:ext cx="129510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06D3590-EDEF-2086-62D1-DE1BA929BEAA}"/>
                </a:ext>
              </a:extLst>
            </p:cNvPr>
            <p:cNvSpPr txBox="1"/>
            <p:nvPr/>
          </p:nvSpPr>
          <p:spPr>
            <a:xfrm>
              <a:off x="8896701" y="1140198"/>
              <a:ext cx="1295101" cy="30777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tb2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8" name="그룹 37">
              <a:extLst>
                <a:ext uri="{FF2B5EF4-FFF2-40B4-BE49-F238E27FC236}">
                  <a16:creationId xmlns:a16="http://schemas.microsoft.com/office/drawing/2014/main" id="{87932F35-3A44-6BE7-6A27-79F5AEF77309}"/>
                </a:ext>
              </a:extLst>
            </p:cNvPr>
            <p:cNvGrpSpPr/>
            <p:nvPr/>
          </p:nvGrpSpPr>
          <p:grpSpPr>
            <a:xfrm>
              <a:off x="1458075" y="1519029"/>
              <a:ext cx="578673" cy="808713"/>
              <a:chOff x="1458075" y="1519029"/>
              <a:chExt cx="578673" cy="808713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863489D6-F423-6644-AC0C-8E169A6A7912}"/>
                  </a:ext>
                </a:extLst>
              </p:cNvPr>
              <p:cNvSpPr txBox="1"/>
              <p:nvPr/>
            </p:nvSpPr>
            <p:spPr>
              <a:xfrm>
                <a:off x="1458075" y="1770109"/>
                <a:ext cx="5786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1</a:t>
                </a:r>
                <a:endParaRPr lang="ko-KR" altLang="en-US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직사각형 32">
                <a:extLst>
                  <a:ext uri="{FF2B5EF4-FFF2-40B4-BE49-F238E27FC236}">
                    <a16:creationId xmlns:a16="http://schemas.microsoft.com/office/drawing/2014/main" id="{A22D0E71-66F9-BD31-4B77-22BA223D3B21}"/>
                  </a:ext>
                </a:extLst>
              </p:cNvPr>
              <p:cNvSpPr/>
              <p:nvPr/>
            </p:nvSpPr>
            <p:spPr>
              <a:xfrm>
                <a:off x="1514475" y="1519029"/>
                <a:ext cx="468954" cy="808713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39" name="그룹 38">
              <a:extLst>
                <a:ext uri="{FF2B5EF4-FFF2-40B4-BE49-F238E27FC236}">
                  <a16:creationId xmlns:a16="http://schemas.microsoft.com/office/drawing/2014/main" id="{B00DA789-0FCA-9447-8158-93C470074B97}"/>
                </a:ext>
              </a:extLst>
            </p:cNvPr>
            <p:cNvGrpSpPr/>
            <p:nvPr/>
          </p:nvGrpSpPr>
          <p:grpSpPr>
            <a:xfrm>
              <a:off x="1458075" y="2378650"/>
              <a:ext cx="578673" cy="808713"/>
              <a:chOff x="1458075" y="1519029"/>
              <a:chExt cx="578673" cy="808713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EBDCE77-44CC-522B-F84C-6F688D34AE1A}"/>
                  </a:ext>
                </a:extLst>
              </p:cNvPr>
              <p:cNvSpPr txBox="1"/>
              <p:nvPr/>
            </p:nvSpPr>
            <p:spPr>
              <a:xfrm>
                <a:off x="1458075" y="1770109"/>
                <a:ext cx="5786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2</a:t>
                </a:r>
                <a:endParaRPr lang="ko-KR" altLang="en-US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직사각형 51">
                <a:extLst>
                  <a:ext uri="{FF2B5EF4-FFF2-40B4-BE49-F238E27FC236}">
                    <a16:creationId xmlns:a16="http://schemas.microsoft.com/office/drawing/2014/main" id="{62993B71-FAE5-23A7-D5C0-C8F76FCC5962}"/>
                  </a:ext>
                </a:extLst>
              </p:cNvPr>
              <p:cNvSpPr/>
              <p:nvPr/>
            </p:nvSpPr>
            <p:spPr>
              <a:xfrm>
                <a:off x="1514475" y="1519029"/>
                <a:ext cx="468954" cy="808713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5" name="그룹 54">
              <a:extLst>
                <a:ext uri="{FF2B5EF4-FFF2-40B4-BE49-F238E27FC236}">
                  <a16:creationId xmlns:a16="http://schemas.microsoft.com/office/drawing/2014/main" id="{71CABA92-47D3-CD44-C497-9A91E3143F5C}"/>
                </a:ext>
              </a:extLst>
            </p:cNvPr>
            <p:cNvGrpSpPr/>
            <p:nvPr/>
          </p:nvGrpSpPr>
          <p:grpSpPr>
            <a:xfrm>
              <a:off x="1458075" y="3238271"/>
              <a:ext cx="578673" cy="808713"/>
              <a:chOff x="1458075" y="1519029"/>
              <a:chExt cx="578673" cy="808713"/>
            </a:xfrm>
          </p:grpSpPr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7DC83D39-FAB9-C160-8489-275E52273310}"/>
                  </a:ext>
                </a:extLst>
              </p:cNvPr>
              <p:cNvSpPr txBox="1"/>
              <p:nvPr/>
            </p:nvSpPr>
            <p:spPr>
              <a:xfrm>
                <a:off x="1458075" y="1770109"/>
                <a:ext cx="5786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3</a:t>
                </a:r>
                <a:endParaRPr lang="ko-KR" altLang="en-US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직사각형 56">
                <a:extLst>
                  <a:ext uri="{FF2B5EF4-FFF2-40B4-BE49-F238E27FC236}">
                    <a16:creationId xmlns:a16="http://schemas.microsoft.com/office/drawing/2014/main" id="{A101E987-637F-18FF-4D6E-796DAB79F95E}"/>
                  </a:ext>
                </a:extLst>
              </p:cNvPr>
              <p:cNvSpPr/>
              <p:nvPr/>
            </p:nvSpPr>
            <p:spPr>
              <a:xfrm>
                <a:off x="1514475" y="1519029"/>
                <a:ext cx="468954" cy="808713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8" name="그룹 57">
              <a:extLst>
                <a:ext uri="{FF2B5EF4-FFF2-40B4-BE49-F238E27FC236}">
                  <a16:creationId xmlns:a16="http://schemas.microsoft.com/office/drawing/2014/main" id="{417111D7-A360-0944-C7C6-8DF4C47D443D}"/>
                </a:ext>
              </a:extLst>
            </p:cNvPr>
            <p:cNvGrpSpPr/>
            <p:nvPr/>
          </p:nvGrpSpPr>
          <p:grpSpPr>
            <a:xfrm>
              <a:off x="1458075" y="4097892"/>
              <a:ext cx="578673" cy="808713"/>
              <a:chOff x="1458075" y="1519029"/>
              <a:chExt cx="578673" cy="808713"/>
            </a:xfrm>
          </p:grpSpPr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7B5169A1-74DD-70CC-5A88-AB5D48212A2D}"/>
                  </a:ext>
                </a:extLst>
              </p:cNvPr>
              <p:cNvSpPr txBox="1"/>
              <p:nvPr/>
            </p:nvSpPr>
            <p:spPr>
              <a:xfrm>
                <a:off x="1458075" y="1770109"/>
                <a:ext cx="5786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4</a:t>
                </a:r>
                <a:endParaRPr lang="ko-KR" altLang="en-US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직사각형 59">
                <a:extLst>
                  <a:ext uri="{FF2B5EF4-FFF2-40B4-BE49-F238E27FC236}">
                    <a16:creationId xmlns:a16="http://schemas.microsoft.com/office/drawing/2014/main" id="{EF2BD3D6-F7F6-ED11-6B0D-B41A23319826}"/>
                  </a:ext>
                </a:extLst>
              </p:cNvPr>
              <p:cNvSpPr/>
              <p:nvPr/>
            </p:nvSpPr>
            <p:spPr>
              <a:xfrm>
                <a:off x="1514475" y="1519029"/>
                <a:ext cx="468954" cy="808713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61" name="그룹 60">
              <a:extLst>
                <a:ext uri="{FF2B5EF4-FFF2-40B4-BE49-F238E27FC236}">
                  <a16:creationId xmlns:a16="http://schemas.microsoft.com/office/drawing/2014/main" id="{882B3A56-C39F-F502-EBEE-C98E0DEB6687}"/>
                </a:ext>
              </a:extLst>
            </p:cNvPr>
            <p:cNvGrpSpPr/>
            <p:nvPr/>
          </p:nvGrpSpPr>
          <p:grpSpPr>
            <a:xfrm>
              <a:off x="1458075" y="4957513"/>
              <a:ext cx="578673" cy="808713"/>
              <a:chOff x="1458075" y="1519029"/>
              <a:chExt cx="578673" cy="808713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890740F3-ECCF-ED17-40D8-743DF0ACFB36}"/>
                  </a:ext>
                </a:extLst>
              </p:cNvPr>
              <p:cNvSpPr txBox="1"/>
              <p:nvPr/>
            </p:nvSpPr>
            <p:spPr>
              <a:xfrm>
                <a:off x="1458075" y="1770109"/>
                <a:ext cx="57867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solidFill>
                      <a:schemeClr val="bg1">
                        <a:lumMod val="6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n5</a:t>
                </a:r>
                <a:endParaRPr lang="ko-KR" altLang="en-US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직사각형 62">
                <a:extLst>
                  <a:ext uri="{FF2B5EF4-FFF2-40B4-BE49-F238E27FC236}">
                    <a16:creationId xmlns:a16="http://schemas.microsoft.com/office/drawing/2014/main" id="{E3FC5DA3-2EA5-2241-6FE2-C34F56CE634E}"/>
                  </a:ext>
                </a:extLst>
              </p:cNvPr>
              <p:cNvSpPr/>
              <p:nvPr/>
            </p:nvSpPr>
            <p:spPr>
              <a:xfrm>
                <a:off x="1514475" y="1519029"/>
                <a:ext cx="468954" cy="808713"/>
              </a:xfrm>
              <a:prstGeom prst="rect">
                <a:avLst/>
              </a:prstGeom>
              <a:noFill/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0792973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FE1F29EF-991A-A46A-616F-31C97DD64626}"/>
              </a:ext>
            </a:extLst>
          </p:cNvPr>
          <p:cNvSpPr txBox="1"/>
          <p:nvPr/>
        </p:nvSpPr>
        <p:spPr>
          <a:xfrm>
            <a:off x="253330" y="231339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endParaRPr lang="ko-KR" altLang="en-US" b="1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50DD6C49-C406-9CE5-0C7B-6A3AAE9071FF}"/>
              </a:ext>
            </a:extLst>
          </p:cNvPr>
          <p:cNvCxnSpPr>
            <a:cxnSpLocks/>
          </p:cNvCxnSpPr>
          <p:nvPr/>
        </p:nvCxnSpPr>
        <p:spPr>
          <a:xfrm>
            <a:off x="686302" y="1483502"/>
            <a:ext cx="1094149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2" name="그룹 61">
            <a:extLst>
              <a:ext uri="{FF2B5EF4-FFF2-40B4-BE49-F238E27FC236}">
                <a16:creationId xmlns:a16="http://schemas.microsoft.com/office/drawing/2014/main" id="{69AA0F40-AD49-E03F-ADB2-944F4C930895}"/>
              </a:ext>
            </a:extLst>
          </p:cNvPr>
          <p:cNvGrpSpPr/>
          <p:nvPr/>
        </p:nvGrpSpPr>
        <p:grpSpPr>
          <a:xfrm>
            <a:off x="2003375" y="1483502"/>
            <a:ext cx="8215529" cy="4330532"/>
            <a:chOff x="2003375" y="1483502"/>
            <a:chExt cx="8215529" cy="4330532"/>
          </a:xfrm>
        </p:grpSpPr>
        <p:pic>
          <p:nvPicPr>
            <p:cNvPr id="16" name="그림 15">
              <a:extLst>
                <a:ext uri="{FF2B5EF4-FFF2-40B4-BE49-F238E27FC236}">
                  <a16:creationId xmlns:a16="http://schemas.microsoft.com/office/drawing/2014/main" id="{9E5C28AA-BA6A-84DC-99CF-44F42F391A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866177" y="1494034"/>
              <a:ext cx="1352727" cy="4320000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595A3E66-6010-0B26-1FBB-6DF63EF800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45069" y="1487863"/>
              <a:ext cx="1352727" cy="4320000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6A5565D3-07D5-5A1A-EC3B-83F26188ED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505"/>
            <a:stretch/>
          </p:blipFill>
          <p:spPr>
            <a:xfrm>
              <a:off x="4752988" y="1486279"/>
              <a:ext cx="1352727" cy="4314852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52D7F60-06E6-4BD7-CF2A-777E0FB04E4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038424" y="1485874"/>
              <a:ext cx="1352727" cy="4320000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357C0973-EE0F-E714-3A4E-A2CCF37F0AE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00866" y="1483502"/>
              <a:ext cx="1352727" cy="4320000"/>
            </a:xfrm>
            <a:prstGeom prst="rect">
              <a:avLst/>
            </a:prstGeom>
          </p:spPr>
        </p:pic>
        <p:pic>
          <p:nvPicPr>
            <p:cNvPr id="19" name="그림 18">
              <a:extLst>
                <a:ext uri="{FF2B5EF4-FFF2-40B4-BE49-F238E27FC236}">
                  <a16:creationId xmlns:a16="http://schemas.microsoft.com/office/drawing/2014/main" id="{F7C00AA0-C438-A64C-4E64-A969B6AD8AF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513450" y="1486677"/>
              <a:ext cx="1352727" cy="4320000"/>
            </a:xfrm>
            <a:prstGeom prst="rect">
              <a:avLst/>
            </a:prstGeom>
          </p:spPr>
        </p:pic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4847896D-DD9B-741F-8B95-C6D8FD178837}"/>
                </a:ext>
              </a:extLst>
            </p:cNvPr>
            <p:cNvCxnSpPr>
              <a:cxnSpLocks/>
            </p:cNvCxnSpPr>
            <p:nvPr/>
          </p:nvCxnSpPr>
          <p:spPr>
            <a:xfrm>
              <a:off x="2003375" y="2347502"/>
              <a:ext cx="8208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DE808D57-34B7-D557-C8BF-F5623623A046}"/>
                </a:ext>
              </a:extLst>
            </p:cNvPr>
            <p:cNvCxnSpPr>
              <a:cxnSpLocks/>
            </p:cNvCxnSpPr>
            <p:nvPr/>
          </p:nvCxnSpPr>
          <p:spPr>
            <a:xfrm>
              <a:off x="2003375" y="3211502"/>
              <a:ext cx="8208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D5C08778-D2FA-8FD2-AF99-D32586A2CE4E}"/>
                </a:ext>
              </a:extLst>
            </p:cNvPr>
            <p:cNvCxnSpPr>
              <a:cxnSpLocks/>
            </p:cNvCxnSpPr>
            <p:nvPr/>
          </p:nvCxnSpPr>
          <p:spPr>
            <a:xfrm>
              <a:off x="2003375" y="4075502"/>
              <a:ext cx="8208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>
              <a:extLst>
                <a:ext uri="{FF2B5EF4-FFF2-40B4-BE49-F238E27FC236}">
                  <a16:creationId xmlns:a16="http://schemas.microsoft.com/office/drawing/2014/main" id="{EAFC5295-39FC-51E5-444B-FB06804ACA9E}"/>
                </a:ext>
              </a:extLst>
            </p:cNvPr>
            <p:cNvCxnSpPr>
              <a:cxnSpLocks/>
            </p:cNvCxnSpPr>
            <p:nvPr/>
          </p:nvCxnSpPr>
          <p:spPr>
            <a:xfrm>
              <a:off x="2003375" y="4939502"/>
              <a:ext cx="8208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이등변 삼각형 29">
              <a:extLst>
                <a:ext uri="{FF2B5EF4-FFF2-40B4-BE49-F238E27FC236}">
                  <a16:creationId xmlns:a16="http://schemas.microsoft.com/office/drawing/2014/main" id="{9462527E-390E-5E75-3739-F2DD251EF8AF}"/>
                </a:ext>
              </a:extLst>
            </p:cNvPr>
            <p:cNvSpPr/>
            <p:nvPr/>
          </p:nvSpPr>
          <p:spPr>
            <a:xfrm rot="14012860">
              <a:off x="9924514" y="5578147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1" name="이등변 삼각형 30">
              <a:extLst>
                <a:ext uri="{FF2B5EF4-FFF2-40B4-BE49-F238E27FC236}">
                  <a16:creationId xmlns:a16="http://schemas.microsoft.com/office/drawing/2014/main" id="{9717D553-7D28-3BBB-A133-A5540B86A6FF}"/>
                </a:ext>
              </a:extLst>
            </p:cNvPr>
            <p:cNvSpPr/>
            <p:nvPr/>
          </p:nvSpPr>
          <p:spPr>
            <a:xfrm rot="14012860">
              <a:off x="9586226" y="5168464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이등변 삼각형 31">
              <a:extLst>
                <a:ext uri="{FF2B5EF4-FFF2-40B4-BE49-F238E27FC236}">
                  <a16:creationId xmlns:a16="http://schemas.microsoft.com/office/drawing/2014/main" id="{B500CE61-9077-AB64-0840-FABAAFD791CB}"/>
                </a:ext>
              </a:extLst>
            </p:cNvPr>
            <p:cNvSpPr/>
            <p:nvPr/>
          </p:nvSpPr>
          <p:spPr>
            <a:xfrm rot="14012860">
              <a:off x="9437789" y="2636177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3" name="이등변 삼각형 32">
              <a:extLst>
                <a:ext uri="{FF2B5EF4-FFF2-40B4-BE49-F238E27FC236}">
                  <a16:creationId xmlns:a16="http://schemas.microsoft.com/office/drawing/2014/main" id="{5EE7AA97-78F2-CD75-1E4F-BC59911A4C8A}"/>
                </a:ext>
              </a:extLst>
            </p:cNvPr>
            <p:cNvSpPr/>
            <p:nvPr/>
          </p:nvSpPr>
          <p:spPr>
            <a:xfrm rot="14012860">
              <a:off x="9586227" y="2397004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4" name="이등변 삼각형 33">
              <a:extLst>
                <a:ext uri="{FF2B5EF4-FFF2-40B4-BE49-F238E27FC236}">
                  <a16:creationId xmlns:a16="http://schemas.microsoft.com/office/drawing/2014/main" id="{0A709EAE-782C-13CD-D681-F50BE50A3DB7}"/>
                </a:ext>
              </a:extLst>
            </p:cNvPr>
            <p:cNvSpPr/>
            <p:nvPr/>
          </p:nvSpPr>
          <p:spPr>
            <a:xfrm rot="14012860">
              <a:off x="9802920" y="5525958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5" name="이등변 삼각형 34">
              <a:extLst>
                <a:ext uri="{FF2B5EF4-FFF2-40B4-BE49-F238E27FC236}">
                  <a16:creationId xmlns:a16="http://schemas.microsoft.com/office/drawing/2014/main" id="{9C910C2C-8DBD-170A-E281-9D9DF74BECEA}"/>
                </a:ext>
              </a:extLst>
            </p:cNvPr>
            <p:cNvSpPr/>
            <p:nvPr/>
          </p:nvSpPr>
          <p:spPr>
            <a:xfrm rot="14012860">
              <a:off x="10064872" y="5602626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6" name="이등변 삼각형 35">
              <a:extLst>
                <a:ext uri="{FF2B5EF4-FFF2-40B4-BE49-F238E27FC236}">
                  <a16:creationId xmlns:a16="http://schemas.microsoft.com/office/drawing/2014/main" id="{086F791D-F296-AAA6-24C4-139DBC117B2C}"/>
                </a:ext>
              </a:extLst>
            </p:cNvPr>
            <p:cNvSpPr/>
            <p:nvPr/>
          </p:nvSpPr>
          <p:spPr>
            <a:xfrm rot="14012860">
              <a:off x="9729710" y="5504130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7" name="이등변 삼각형 36">
              <a:extLst>
                <a:ext uri="{FF2B5EF4-FFF2-40B4-BE49-F238E27FC236}">
                  <a16:creationId xmlns:a16="http://schemas.microsoft.com/office/drawing/2014/main" id="{B3764DA6-F82F-43AF-A20E-B26BEC99C92B}"/>
                </a:ext>
              </a:extLst>
            </p:cNvPr>
            <p:cNvSpPr/>
            <p:nvPr/>
          </p:nvSpPr>
          <p:spPr>
            <a:xfrm rot="14012860">
              <a:off x="9540969" y="5483125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8" name="이등변 삼각형 37">
              <a:extLst>
                <a:ext uri="{FF2B5EF4-FFF2-40B4-BE49-F238E27FC236}">
                  <a16:creationId xmlns:a16="http://schemas.microsoft.com/office/drawing/2014/main" id="{6949E177-D205-278F-6BA1-92F9832E7CD4}"/>
                </a:ext>
              </a:extLst>
            </p:cNvPr>
            <p:cNvSpPr/>
            <p:nvPr/>
          </p:nvSpPr>
          <p:spPr>
            <a:xfrm rot="14012860">
              <a:off x="9400611" y="5537124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9" name="이등변 삼각형 38">
              <a:extLst>
                <a:ext uri="{FF2B5EF4-FFF2-40B4-BE49-F238E27FC236}">
                  <a16:creationId xmlns:a16="http://schemas.microsoft.com/office/drawing/2014/main" id="{392E0039-FE1A-27D1-936D-5A4B8B005703}"/>
                </a:ext>
              </a:extLst>
            </p:cNvPr>
            <p:cNvSpPr/>
            <p:nvPr/>
          </p:nvSpPr>
          <p:spPr>
            <a:xfrm rot="14012860">
              <a:off x="9283261" y="5548625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0" name="이등변 삼각형 39">
              <a:extLst>
                <a:ext uri="{FF2B5EF4-FFF2-40B4-BE49-F238E27FC236}">
                  <a16:creationId xmlns:a16="http://schemas.microsoft.com/office/drawing/2014/main" id="{5DAE473B-3CBA-7290-BEEE-44431C6AF0BF}"/>
                </a:ext>
              </a:extLst>
            </p:cNvPr>
            <p:cNvSpPr/>
            <p:nvPr/>
          </p:nvSpPr>
          <p:spPr>
            <a:xfrm rot="14012860">
              <a:off x="9154551" y="5575780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이등변 삼각형 40">
              <a:extLst>
                <a:ext uri="{FF2B5EF4-FFF2-40B4-BE49-F238E27FC236}">
                  <a16:creationId xmlns:a16="http://schemas.microsoft.com/office/drawing/2014/main" id="{0D4F119F-A429-7EB2-70D4-5410F956AF38}"/>
                </a:ext>
              </a:extLst>
            </p:cNvPr>
            <p:cNvSpPr/>
            <p:nvPr/>
          </p:nvSpPr>
          <p:spPr>
            <a:xfrm rot="14012860">
              <a:off x="9121609" y="5518829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2" name="이등변 삼각형 41">
              <a:extLst>
                <a:ext uri="{FF2B5EF4-FFF2-40B4-BE49-F238E27FC236}">
                  <a16:creationId xmlns:a16="http://schemas.microsoft.com/office/drawing/2014/main" id="{4B1396E0-932B-33EB-D586-1B579CC6A6C5}"/>
                </a:ext>
              </a:extLst>
            </p:cNvPr>
            <p:cNvSpPr/>
            <p:nvPr/>
          </p:nvSpPr>
          <p:spPr>
            <a:xfrm rot="14012860">
              <a:off x="9009230" y="5536189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3" name="이등변 삼각형 42">
              <a:extLst>
                <a:ext uri="{FF2B5EF4-FFF2-40B4-BE49-F238E27FC236}">
                  <a16:creationId xmlns:a16="http://schemas.microsoft.com/office/drawing/2014/main" id="{2A22313A-0DBD-BAE0-5800-8C178846728B}"/>
                </a:ext>
              </a:extLst>
            </p:cNvPr>
            <p:cNvSpPr/>
            <p:nvPr/>
          </p:nvSpPr>
          <p:spPr>
            <a:xfrm rot="14012860">
              <a:off x="9851806" y="2525226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이등변 삼각형 43">
              <a:extLst>
                <a:ext uri="{FF2B5EF4-FFF2-40B4-BE49-F238E27FC236}">
                  <a16:creationId xmlns:a16="http://schemas.microsoft.com/office/drawing/2014/main" id="{DFDFFD60-EFB4-9A76-D9DA-247C19643154}"/>
                </a:ext>
              </a:extLst>
            </p:cNvPr>
            <p:cNvSpPr/>
            <p:nvPr/>
          </p:nvSpPr>
          <p:spPr>
            <a:xfrm rot="14012860">
              <a:off x="9611225" y="1594230"/>
              <a:ext cx="43200" cy="162000"/>
            </a:xfrm>
            <a:prstGeom prst="triangle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2" name="직선 연결선 1">
              <a:extLst>
                <a:ext uri="{FF2B5EF4-FFF2-40B4-BE49-F238E27FC236}">
                  <a16:creationId xmlns:a16="http://schemas.microsoft.com/office/drawing/2014/main" id="{5FE0FA42-DE6F-1F32-33EE-5FC851F68F97}"/>
                </a:ext>
              </a:extLst>
            </p:cNvPr>
            <p:cNvCxnSpPr/>
            <p:nvPr/>
          </p:nvCxnSpPr>
          <p:spPr>
            <a:xfrm>
              <a:off x="2157873" y="5692140"/>
              <a:ext cx="334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8F77304-0987-015A-91D5-DFB8D3647BC7}"/>
                </a:ext>
              </a:extLst>
            </p:cNvPr>
            <p:cNvSpPr txBox="1"/>
            <p:nvPr/>
          </p:nvSpPr>
          <p:spPr>
            <a:xfrm>
              <a:off x="2055006" y="5453229"/>
              <a:ext cx="5405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 um</a:t>
              </a:r>
              <a:endParaRPr lang="ko-KR" alt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EED0505A-6A7A-0A9A-64BB-8D3F1F8564A4}"/>
              </a:ext>
            </a:extLst>
          </p:cNvPr>
          <p:cNvSpPr txBox="1"/>
          <p:nvPr/>
        </p:nvSpPr>
        <p:spPr>
          <a:xfrm>
            <a:off x="2055006" y="5855013"/>
            <a:ext cx="405697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Control (mKO2-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1E0FBD8-C1A0-B6AC-9384-364BF52C2F9C}"/>
              </a:ext>
            </a:extLst>
          </p:cNvPr>
          <p:cNvSpPr txBox="1"/>
          <p:nvPr/>
        </p:nvSpPr>
        <p:spPr>
          <a:xfrm>
            <a:off x="6176701" y="5855013"/>
            <a:ext cx="404784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18 </a:t>
            </a:r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e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(mKO2+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169BA9E6-E1A2-7AB5-7346-F000F634A3A3}"/>
              </a:ext>
            </a:extLst>
          </p:cNvPr>
          <p:cNvGrpSpPr/>
          <p:nvPr/>
        </p:nvGrpSpPr>
        <p:grpSpPr>
          <a:xfrm>
            <a:off x="1458075" y="1519029"/>
            <a:ext cx="578673" cy="808713"/>
            <a:chOff x="1458075" y="1519029"/>
            <a:chExt cx="578673" cy="808713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C7C4E14-8392-8F2D-01AA-43418E829327}"/>
                </a:ext>
              </a:extLst>
            </p:cNvPr>
            <p:cNvSpPr txBox="1"/>
            <p:nvPr/>
          </p:nvSpPr>
          <p:spPr>
            <a:xfrm>
              <a:off x="1458075" y="1770109"/>
              <a:ext cx="57867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1</a:t>
              </a:r>
              <a:endParaRPr lang="ko-KR" altLang="en-US" sz="12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직사각형 20">
              <a:extLst>
                <a:ext uri="{FF2B5EF4-FFF2-40B4-BE49-F238E27FC236}">
                  <a16:creationId xmlns:a16="http://schemas.microsoft.com/office/drawing/2014/main" id="{2C00B489-D3FD-E079-017A-45D2651EA254}"/>
                </a:ext>
              </a:extLst>
            </p:cNvPr>
            <p:cNvSpPr/>
            <p:nvPr/>
          </p:nvSpPr>
          <p:spPr>
            <a:xfrm>
              <a:off x="1514475" y="1519029"/>
              <a:ext cx="468954" cy="808713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2C7FDBC6-E1C3-D4CD-7682-360635B3CDD3}"/>
              </a:ext>
            </a:extLst>
          </p:cNvPr>
          <p:cNvGrpSpPr/>
          <p:nvPr/>
        </p:nvGrpSpPr>
        <p:grpSpPr>
          <a:xfrm>
            <a:off x="1458075" y="2378650"/>
            <a:ext cx="578673" cy="808713"/>
            <a:chOff x="1458075" y="1519029"/>
            <a:chExt cx="578673" cy="808713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FAF1E85-FAE0-FB77-4CA7-ADAC29B08D28}"/>
                </a:ext>
              </a:extLst>
            </p:cNvPr>
            <p:cNvSpPr txBox="1"/>
            <p:nvPr/>
          </p:nvSpPr>
          <p:spPr>
            <a:xfrm>
              <a:off x="1458075" y="1770109"/>
              <a:ext cx="57867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2</a:t>
              </a:r>
              <a:endParaRPr lang="ko-KR" altLang="en-US" sz="12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직사각형 45">
              <a:extLst>
                <a:ext uri="{FF2B5EF4-FFF2-40B4-BE49-F238E27FC236}">
                  <a16:creationId xmlns:a16="http://schemas.microsoft.com/office/drawing/2014/main" id="{4630D1E9-0791-8C30-7FE4-B16BBD91E18F}"/>
                </a:ext>
              </a:extLst>
            </p:cNvPr>
            <p:cNvSpPr/>
            <p:nvPr/>
          </p:nvSpPr>
          <p:spPr>
            <a:xfrm>
              <a:off x="1514475" y="1519029"/>
              <a:ext cx="468954" cy="808713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F1F013EA-B950-9308-296F-1F0B86ECCAA4}"/>
              </a:ext>
            </a:extLst>
          </p:cNvPr>
          <p:cNvGrpSpPr/>
          <p:nvPr/>
        </p:nvGrpSpPr>
        <p:grpSpPr>
          <a:xfrm>
            <a:off x="1458075" y="3238271"/>
            <a:ext cx="578673" cy="808713"/>
            <a:chOff x="1458075" y="1519029"/>
            <a:chExt cx="578673" cy="808713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E9B8EE7-332A-35C0-9771-F6CD3DA747BE}"/>
                </a:ext>
              </a:extLst>
            </p:cNvPr>
            <p:cNvSpPr txBox="1"/>
            <p:nvPr/>
          </p:nvSpPr>
          <p:spPr>
            <a:xfrm>
              <a:off x="1458075" y="1770109"/>
              <a:ext cx="57867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3</a:t>
              </a:r>
              <a:endParaRPr lang="ko-KR" altLang="en-US" sz="12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직사각형 48">
              <a:extLst>
                <a:ext uri="{FF2B5EF4-FFF2-40B4-BE49-F238E27FC236}">
                  <a16:creationId xmlns:a16="http://schemas.microsoft.com/office/drawing/2014/main" id="{6EEF31A7-B9C5-8498-340F-05A8BA3BDCE6}"/>
                </a:ext>
              </a:extLst>
            </p:cNvPr>
            <p:cNvSpPr/>
            <p:nvPr/>
          </p:nvSpPr>
          <p:spPr>
            <a:xfrm>
              <a:off x="1514475" y="1519029"/>
              <a:ext cx="468954" cy="808713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50" name="그룹 49">
            <a:extLst>
              <a:ext uri="{FF2B5EF4-FFF2-40B4-BE49-F238E27FC236}">
                <a16:creationId xmlns:a16="http://schemas.microsoft.com/office/drawing/2014/main" id="{418B28FC-6FFB-0772-A59B-E293582AC2E6}"/>
              </a:ext>
            </a:extLst>
          </p:cNvPr>
          <p:cNvGrpSpPr/>
          <p:nvPr/>
        </p:nvGrpSpPr>
        <p:grpSpPr>
          <a:xfrm>
            <a:off x="1458075" y="4097892"/>
            <a:ext cx="578673" cy="808713"/>
            <a:chOff x="1458075" y="1519029"/>
            <a:chExt cx="578673" cy="808713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4A235AF-AE0D-693A-1FE4-5D1DAC961E57}"/>
                </a:ext>
              </a:extLst>
            </p:cNvPr>
            <p:cNvSpPr txBox="1"/>
            <p:nvPr/>
          </p:nvSpPr>
          <p:spPr>
            <a:xfrm>
              <a:off x="1458075" y="1770109"/>
              <a:ext cx="57867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4</a:t>
              </a:r>
              <a:endParaRPr lang="ko-KR" altLang="en-US" sz="12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직사각형 51">
              <a:extLst>
                <a:ext uri="{FF2B5EF4-FFF2-40B4-BE49-F238E27FC236}">
                  <a16:creationId xmlns:a16="http://schemas.microsoft.com/office/drawing/2014/main" id="{38565F19-4421-A96B-07DD-B4F4E8253F12}"/>
                </a:ext>
              </a:extLst>
            </p:cNvPr>
            <p:cNvSpPr/>
            <p:nvPr/>
          </p:nvSpPr>
          <p:spPr>
            <a:xfrm>
              <a:off x="1514475" y="1519029"/>
              <a:ext cx="468954" cy="808713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53" name="그룹 52">
            <a:extLst>
              <a:ext uri="{FF2B5EF4-FFF2-40B4-BE49-F238E27FC236}">
                <a16:creationId xmlns:a16="http://schemas.microsoft.com/office/drawing/2014/main" id="{D65FA455-FFA3-4705-DBF2-B1043112B31E}"/>
              </a:ext>
            </a:extLst>
          </p:cNvPr>
          <p:cNvGrpSpPr/>
          <p:nvPr/>
        </p:nvGrpSpPr>
        <p:grpSpPr>
          <a:xfrm>
            <a:off x="1458075" y="4957513"/>
            <a:ext cx="578673" cy="808713"/>
            <a:chOff x="1458075" y="1519029"/>
            <a:chExt cx="578673" cy="808713"/>
          </a:xfrm>
        </p:grpSpPr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209EE7E4-24B6-707A-34AE-0131DB7EDAE0}"/>
                </a:ext>
              </a:extLst>
            </p:cNvPr>
            <p:cNvSpPr txBox="1"/>
            <p:nvPr/>
          </p:nvSpPr>
          <p:spPr>
            <a:xfrm>
              <a:off x="1458075" y="1770109"/>
              <a:ext cx="57867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in5</a:t>
              </a:r>
              <a:endParaRPr lang="ko-KR" altLang="en-US" sz="1200" b="1" dirty="0">
                <a:solidFill>
                  <a:schemeClr val="bg1">
                    <a:lumMod val="6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직사각형 54">
              <a:extLst>
                <a:ext uri="{FF2B5EF4-FFF2-40B4-BE49-F238E27FC236}">
                  <a16:creationId xmlns:a16="http://schemas.microsoft.com/office/drawing/2014/main" id="{A29B561E-FEDC-8613-BD41-352B1BE14467}"/>
                </a:ext>
              </a:extLst>
            </p:cNvPr>
            <p:cNvSpPr/>
            <p:nvPr/>
          </p:nvSpPr>
          <p:spPr>
            <a:xfrm>
              <a:off x="1514475" y="1519029"/>
              <a:ext cx="468954" cy="808713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297DDD05-B39F-9F85-E3F5-E5B1CCC4791F}"/>
              </a:ext>
            </a:extLst>
          </p:cNvPr>
          <p:cNvSpPr txBox="1"/>
          <p:nvPr/>
        </p:nvSpPr>
        <p:spPr>
          <a:xfrm>
            <a:off x="2072397" y="1140198"/>
            <a:ext cx="129510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C8F0BE3-7825-B39B-B611-2C9A2B2F240A}"/>
              </a:ext>
            </a:extLst>
          </p:cNvPr>
          <p:cNvSpPr txBox="1"/>
          <p:nvPr/>
        </p:nvSpPr>
        <p:spPr>
          <a:xfrm>
            <a:off x="3429678" y="1140198"/>
            <a:ext cx="129510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E93EC8A-9D24-83B8-8F40-2411CF0E9102}"/>
              </a:ext>
            </a:extLst>
          </p:cNvPr>
          <p:cNvSpPr txBox="1"/>
          <p:nvPr/>
        </p:nvSpPr>
        <p:spPr>
          <a:xfrm>
            <a:off x="4800899" y="1140198"/>
            <a:ext cx="129510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5956BA11-758E-B231-374F-4BE62B092EA3}"/>
              </a:ext>
            </a:extLst>
          </p:cNvPr>
          <p:cNvSpPr txBox="1"/>
          <p:nvPr/>
        </p:nvSpPr>
        <p:spPr>
          <a:xfrm>
            <a:off x="6168199" y="1140198"/>
            <a:ext cx="129510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EB1BE2B-3F02-2480-504A-7C52B7B49A48}"/>
              </a:ext>
            </a:extLst>
          </p:cNvPr>
          <p:cNvSpPr txBox="1"/>
          <p:nvPr/>
        </p:nvSpPr>
        <p:spPr>
          <a:xfrm>
            <a:off x="7525480" y="1140198"/>
            <a:ext cx="129510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A4D1D2C-D45B-DCA7-E867-E04B6BD80A4F}"/>
              </a:ext>
            </a:extLst>
          </p:cNvPr>
          <p:cNvSpPr txBox="1"/>
          <p:nvPr/>
        </p:nvSpPr>
        <p:spPr>
          <a:xfrm>
            <a:off x="8896701" y="1140198"/>
            <a:ext cx="1295101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dH1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dU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6755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4E45DBF8-4B1E-E04B-FDE8-8A0E3AFCC8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97651">
            <a:off x="3312392" y="145916"/>
            <a:ext cx="6909629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70596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그림 13">
            <a:extLst>
              <a:ext uri="{FF2B5EF4-FFF2-40B4-BE49-F238E27FC236}">
                <a16:creationId xmlns:a16="http://schemas.microsoft.com/office/drawing/2014/main" id="{0F0FFF99-2DA9-E186-6637-241DF9986A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97651">
            <a:off x="3312392" y="145916"/>
            <a:ext cx="6909629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67977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0021B2A8-E4B7-C550-FE16-A9349F4AB6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97651">
            <a:off x="3312392" y="145916"/>
            <a:ext cx="6909629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05188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그림 11">
            <a:extLst>
              <a:ext uri="{FF2B5EF4-FFF2-40B4-BE49-F238E27FC236}">
                <a16:creationId xmlns:a16="http://schemas.microsoft.com/office/drawing/2014/main" id="{046B86B0-8B60-D4D6-641F-7FE52CF060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97651">
            <a:off x="3312392" y="145916"/>
            <a:ext cx="6909629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91582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9E708291-E91A-FF2C-08FC-F6DC4118DC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783012">
            <a:off x="3323157" y="156813"/>
            <a:ext cx="6909629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48912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C793C8F0-CD13-C984-2246-507192931D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70723">
            <a:off x="1627191" y="-250214"/>
            <a:ext cx="6480000" cy="6431581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9D0D30E2-453F-4E56-8919-650216B010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977431">
            <a:off x="1617129" y="-260216"/>
            <a:ext cx="6481631" cy="64332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CCACFEA-CC82-EFD1-1262-143E5DE2EA5D}"/>
              </a:ext>
            </a:extLst>
          </p:cNvPr>
          <p:cNvSpPr txBox="1"/>
          <p:nvPr/>
        </p:nvSpPr>
        <p:spPr>
          <a:xfrm>
            <a:off x="-39273" y="0"/>
            <a:ext cx="27298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b="1" dirty="0"/>
              <a:t>E15-P10_mKO2+_2-2</a:t>
            </a:r>
          </a:p>
        </p:txBody>
      </p:sp>
    </p:spTree>
    <p:extLst>
      <p:ext uri="{BB962C8B-B14F-4D97-AF65-F5344CB8AC3E}">
        <p14:creationId xmlns:p14="http://schemas.microsoft.com/office/powerpoint/2010/main" val="29252902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>
            <a:extLst>
              <a:ext uri="{FF2B5EF4-FFF2-40B4-BE49-F238E27FC236}">
                <a16:creationId xmlns:a16="http://schemas.microsoft.com/office/drawing/2014/main" id="{1B6147F6-ADCF-E095-1098-9E00B3D8D9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70723">
            <a:off x="1627191" y="-250214"/>
            <a:ext cx="6480000" cy="6431581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49612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003DCE39-E650-938F-87E9-160C2A3649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70723">
            <a:off x="1627191" y="-250214"/>
            <a:ext cx="6480000" cy="6431581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11122A5A-656D-AECF-264A-34A7C020FCD2}"/>
              </a:ext>
            </a:extLst>
          </p:cNvPr>
          <p:cNvSpPr/>
          <p:nvPr/>
        </p:nvSpPr>
        <p:spPr>
          <a:xfrm>
            <a:off x="5317445" y="694916"/>
            <a:ext cx="1800000" cy="5760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614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64</Words>
  <Application>Microsoft Office PowerPoint</Application>
  <PresentationFormat>와이드스크린</PresentationFormat>
  <Paragraphs>32</Paragraphs>
  <Slides>1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1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4</cp:revision>
  <dcterms:created xsi:type="dcterms:W3CDTF">2023-03-22T02:06:27Z</dcterms:created>
  <dcterms:modified xsi:type="dcterms:W3CDTF">2024-09-30T05:41:34Z</dcterms:modified>
</cp:coreProperties>
</file>